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8229600" cy="64008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225440" y="685440"/>
            <a:ext cx="440712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E04730-EE61-4D06-B027-FB8199B45A31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7960F0-5214-4F34-A832-BA3D0E81E31E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PlaceHolder 1"/>
          <p:cNvSpPr>
            <a:spLocks noGrp="1"/>
          </p:cNvSpPr>
          <p:nvPr>
            <p:ph type="sldImg"/>
          </p:nvPr>
        </p:nvSpPr>
        <p:spPr>
          <a:xfrm>
            <a:off x="1225440" y="685800"/>
            <a:ext cx="4407120" cy="3429000"/>
          </a:xfrm>
          <a:prstGeom prst="rect">
            <a:avLst/>
          </a:prstGeom>
          <a:ln w="0">
            <a:noFill/>
          </a:ln>
        </p:spPr>
      </p:sp>
      <p:sp>
        <p:nvSpPr>
          <p:cNvPr id="27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8086ED-87F5-4BCB-98C9-E1BC46F595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12920" y="257040"/>
            <a:ext cx="740376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12920" y="1494000"/>
            <a:ext cx="74037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12920" y="3700800"/>
            <a:ext cx="74037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083C0-67F8-4EF7-AEAA-37EC477913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12920" y="257040"/>
            <a:ext cx="740376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12920" y="1494000"/>
            <a:ext cx="36129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206960" y="1494000"/>
            <a:ext cx="36129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12920" y="3700800"/>
            <a:ext cx="36129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206960" y="3700800"/>
            <a:ext cx="36129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D12075-58E5-4039-8DE7-472623D8A5D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12920" y="257040"/>
            <a:ext cx="740376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12920" y="1494000"/>
            <a:ext cx="238392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916360" y="1494000"/>
            <a:ext cx="238392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419800" y="1494000"/>
            <a:ext cx="238392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12920" y="3700800"/>
            <a:ext cx="238392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916360" y="3700800"/>
            <a:ext cx="238392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419800" y="3700800"/>
            <a:ext cx="238392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4B0406-8DBF-4779-9379-14FA97E6C4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12920" y="257040"/>
            <a:ext cx="740376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12920" y="1494000"/>
            <a:ext cx="7403760" cy="4224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F5B64-2C2D-495E-9D2F-48C28C5BBA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12920" y="257040"/>
            <a:ext cx="740376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12920" y="1494000"/>
            <a:ext cx="7403760" cy="42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0F3148-50B8-47AB-8903-D624B41309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12920" y="257040"/>
            <a:ext cx="740376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12920" y="1494000"/>
            <a:ext cx="3612960" cy="42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206960" y="1494000"/>
            <a:ext cx="3612960" cy="42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2B6A68-F46F-46A0-B80C-347B306DEA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12920" y="257040"/>
            <a:ext cx="740376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A79316-AF63-402F-AD2D-A3D1C3EC32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12920" y="257040"/>
            <a:ext cx="7403760" cy="4947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94A759-31E5-4009-85F1-72C9D684E2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12920" y="257040"/>
            <a:ext cx="740376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12920" y="1494000"/>
            <a:ext cx="36129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206960" y="1494000"/>
            <a:ext cx="3612960" cy="42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12920" y="3700800"/>
            <a:ext cx="36129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69C9E9-BDF9-4CA6-9F86-75B3ADDB77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12920" y="257040"/>
            <a:ext cx="740376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12920" y="1494000"/>
            <a:ext cx="3612960" cy="42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206960" y="1494000"/>
            <a:ext cx="36129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206960" y="3700800"/>
            <a:ext cx="36129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D3BB8A-1800-4A33-9C18-4E630A9A72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12920" y="257040"/>
            <a:ext cx="740376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12920" y="1494000"/>
            <a:ext cx="36129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206960" y="1494000"/>
            <a:ext cx="36129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12920" y="3700800"/>
            <a:ext cx="7403760" cy="201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881967-9542-4209-97E4-A003E58EB6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12920" y="257040"/>
            <a:ext cx="7403760" cy="106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12920" y="1494000"/>
            <a:ext cx="7403760" cy="422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12920" y="5829480"/>
            <a:ext cx="1917360" cy="44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813040" y="5829480"/>
            <a:ext cx="2603520" cy="44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899320" y="5829480"/>
            <a:ext cx="1917360" cy="444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590BA0-647C-4BBC-8AA3-151BB89A8783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96840" y="76320"/>
            <a:ext cx="8037000" cy="6247800"/>
            <a:chOff x="96840" y="76320"/>
            <a:chExt cx="8037000" cy="6247800"/>
          </a:xfrm>
        </p:grpSpPr>
        <p:grpSp>
          <p:nvGrpSpPr>
            <p:cNvPr id="49" name=""/>
            <p:cNvGrpSpPr/>
            <p:nvPr/>
          </p:nvGrpSpPr>
          <p:grpSpPr>
            <a:xfrm>
              <a:off x="96840" y="76320"/>
              <a:ext cx="6708600" cy="6247800"/>
              <a:chOff x="96840" y="76320"/>
              <a:chExt cx="6708600" cy="6247800"/>
            </a:xfrm>
          </p:grpSpPr>
          <p:sp>
            <p:nvSpPr>
              <p:cNvPr id="50" name=""/>
              <p:cNvSpPr/>
              <p:nvPr/>
            </p:nvSpPr>
            <p:spPr>
              <a:xfrm>
                <a:off x="133200" y="76320"/>
                <a:ext cx="719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2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96840" y="2048040"/>
                <a:ext cx="790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2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96840" y="4037040"/>
                <a:ext cx="790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200" spc="-1" strike="noStrike">
                    <a:solidFill>
                      <a:srgbClr val="000000"/>
                    </a:solidFill>
                    <a:latin typeface="Arial"/>
                  </a:rPr>
                  <a:t>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AutoShape 92"/>
              <p:cNvSpPr/>
              <p:nvPr/>
            </p:nvSpPr>
            <p:spPr>
              <a:xfrm>
                <a:off x="322200" y="3902040"/>
                <a:ext cx="2209680" cy="1488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 Box 6"/>
              <p:cNvSpPr/>
              <p:nvPr/>
            </p:nvSpPr>
            <p:spPr>
              <a:xfrm rot="16200000">
                <a:off x="233640" y="964800"/>
                <a:ext cx="1093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BAFF/</a:t>
                </a:r>
                <a:r>
                  <a:rPr b="0" lang="it-IT" sz="9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-actin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 Box 6"/>
              <p:cNvSpPr/>
              <p:nvPr/>
            </p:nvSpPr>
            <p:spPr>
              <a:xfrm rot="16200000">
                <a:off x="233640" y="2779200"/>
                <a:ext cx="10936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CXCL-10/</a:t>
                </a:r>
                <a:r>
                  <a:rPr b="0" lang="it-IT" sz="9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-actin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 Box 6"/>
              <p:cNvSpPr/>
              <p:nvPr/>
            </p:nvSpPr>
            <p:spPr>
              <a:xfrm rot="16200000">
                <a:off x="233280" y="4531320"/>
                <a:ext cx="109404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MxA/</a:t>
                </a:r>
                <a:r>
                  <a:rPr b="0" lang="it-IT" sz="9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</a:t>
                </a:r>
                <a:r>
                  <a:rPr b="0" lang="it-IT" sz="900" spc="-1" strike="noStrike">
                    <a:solidFill>
                      <a:srgbClr val="000000"/>
                    </a:solidFill>
                    <a:latin typeface="Arial"/>
                  </a:rPr>
                  <a:t>-actin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7" name=""/>
              <p:cNvGrpSpPr/>
              <p:nvPr/>
            </p:nvGrpSpPr>
            <p:grpSpPr>
              <a:xfrm>
                <a:off x="865080" y="4021200"/>
                <a:ext cx="2771640" cy="1967400"/>
                <a:chOff x="865080" y="4021200"/>
                <a:chExt cx="2771640" cy="1967400"/>
              </a:xfrm>
            </p:grpSpPr>
            <p:grpSp>
              <p:nvGrpSpPr>
                <p:cNvPr id="58" name=""/>
                <p:cNvGrpSpPr/>
                <p:nvPr/>
              </p:nvGrpSpPr>
              <p:grpSpPr>
                <a:xfrm>
                  <a:off x="1520640" y="5851080"/>
                  <a:ext cx="1596960" cy="137520"/>
                  <a:chOff x="1520640" y="5851080"/>
                  <a:chExt cx="1596960" cy="137520"/>
                </a:xfrm>
              </p:grpSpPr>
              <p:sp>
                <p:nvSpPr>
                  <p:cNvPr id="59" name="Rectangle 132"/>
                  <p:cNvSpPr/>
                  <p:nvPr/>
                </p:nvSpPr>
                <p:spPr>
                  <a:xfrm>
                    <a:off x="1520640" y="5851080"/>
                    <a:ext cx="1350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900" spc="-1" strike="noStrike">
                        <a:solidFill>
                          <a:srgbClr val="000000"/>
                        </a:solidFill>
                        <a:latin typeface="Arial"/>
                      </a:rPr>
                      <a:t>T0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Rectangle 133"/>
                  <p:cNvSpPr/>
                  <p:nvPr/>
                </p:nvSpPr>
                <p:spPr>
                  <a:xfrm>
                    <a:off x="1991520" y="5851080"/>
                    <a:ext cx="13500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900" spc="-1" strike="noStrike">
                        <a:solidFill>
                          <a:srgbClr val="000000"/>
                        </a:solidFill>
                        <a:latin typeface="Arial"/>
                      </a:rPr>
                      <a:t>T2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" name="Rectangle 134"/>
                  <p:cNvSpPr/>
                  <p:nvPr/>
                </p:nvSpPr>
                <p:spPr>
                  <a:xfrm>
                    <a:off x="2449080" y="5851080"/>
                    <a:ext cx="19872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900" spc="-1" strike="noStrike">
                        <a:solidFill>
                          <a:srgbClr val="000000"/>
                        </a:solidFill>
                        <a:latin typeface="Arial"/>
                      </a:rPr>
                      <a:t>T42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" name="Rectangle 135"/>
                  <p:cNvSpPr/>
                  <p:nvPr/>
                </p:nvSpPr>
                <p:spPr>
                  <a:xfrm>
                    <a:off x="2918880" y="5851080"/>
                    <a:ext cx="198720" cy="1375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900" spc="-1" strike="noStrike">
                        <a:solidFill>
                          <a:srgbClr val="000000"/>
                        </a:solidFill>
                        <a:latin typeface="Arial"/>
                      </a:rPr>
                      <a:t>T44</a:t>
                    </a:r>
                    <a:endParaRPr b="0" lang="en-US" sz="9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3" name=""/>
                <p:cNvGrpSpPr/>
                <p:nvPr/>
              </p:nvGrpSpPr>
              <p:grpSpPr>
                <a:xfrm>
                  <a:off x="865080" y="4021200"/>
                  <a:ext cx="2771640" cy="1762920"/>
                  <a:chOff x="865080" y="4021200"/>
                  <a:chExt cx="2771640" cy="1762920"/>
                </a:xfrm>
              </p:grpSpPr>
              <p:pic>
                <p:nvPicPr>
                  <p:cNvPr id="64" name="" descr=""/>
                  <p:cNvPicPr/>
                  <p:nvPr/>
                </p:nvPicPr>
                <p:blipFill>
                  <a:blip r:embed="rId1"/>
                  <a:srcRect l="0" t="7639" r="0" b="0"/>
                  <a:stretch/>
                </p:blipFill>
                <p:spPr>
                  <a:xfrm>
                    <a:off x="865080" y="4021200"/>
                    <a:ext cx="2771640" cy="1762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5" name=""/>
                  <p:cNvSpPr/>
                  <p:nvPr/>
                </p:nvSpPr>
                <p:spPr>
                  <a:xfrm>
                    <a:off x="919440" y="5615280"/>
                    <a:ext cx="2553120" cy="7272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25920" bIns="259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66" name=""/>
              <p:cNvGrpSpPr/>
              <p:nvPr/>
            </p:nvGrpSpPr>
            <p:grpSpPr>
              <a:xfrm>
                <a:off x="865080" y="135000"/>
                <a:ext cx="2771640" cy="1763640"/>
                <a:chOff x="865080" y="135000"/>
                <a:chExt cx="2771640" cy="1763640"/>
              </a:xfrm>
            </p:grpSpPr>
            <p:pic>
              <p:nvPicPr>
                <p:cNvPr id="67" name="" descr=""/>
                <p:cNvPicPr/>
                <p:nvPr/>
              </p:nvPicPr>
              <p:blipFill>
                <a:blip r:embed="rId2"/>
                <a:srcRect l="0" t="7639" r="0" b="0"/>
                <a:stretch/>
              </p:blipFill>
              <p:spPr>
                <a:xfrm>
                  <a:off x="865080" y="135000"/>
                  <a:ext cx="2771640" cy="17636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8" name=""/>
                <p:cNvSpPr/>
                <p:nvPr/>
              </p:nvSpPr>
              <p:spPr>
                <a:xfrm>
                  <a:off x="946800" y="1737360"/>
                  <a:ext cx="2552760" cy="72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5920" bIns="2592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9" name=""/>
              <p:cNvGrpSpPr/>
              <p:nvPr/>
            </p:nvGrpSpPr>
            <p:grpSpPr>
              <a:xfrm>
                <a:off x="865080" y="2084400"/>
                <a:ext cx="2771640" cy="1751040"/>
                <a:chOff x="865080" y="2084400"/>
                <a:chExt cx="2771640" cy="1751040"/>
              </a:xfrm>
            </p:grpSpPr>
            <p:pic>
              <p:nvPicPr>
                <p:cNvPr id="70" name="" descr=""/>
                <p:cNvPicPr/>
                <p:nvPr/>
              </p:nvPicPr>
              <p:blipFill>
                <a:blip r:embed="rId3"/>
                <a:srcRect l="0" t="8352" r="0" b="0"/>
                <a:stretch/>
              </p:blipFill>
              <p:spPr>
                <a:xfrm>
                  <a:off x="865080" y="2084400"/>
                  <a:ext cx="2771640" cy="175104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71" name=""/>
                <p:cNvSpPr/>
                <p:nvPr/>
              </p:nvSpPr>
              <p:spPr>
                <a:xfrm>
                  <a:off x="924120" y="3669480"/>
                  <a:ext cx="2552760" cy="727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5920" bIns="2592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2" name=""/>
              <p:cNvGrpSpPr/>
              <p:nvPr/>
            </p:nvGrpSpPr>
            <p:grpSpPr>
              <a:xfrm>
                <a:off x="3290760" y="76320"/>
                <a:ext cx="3514680" cy="6247800"/>
                <a:chOff x="3290760" y="76320"/>
                <a:chExt cx="3514680" cy="6247800"/>
              </a:xfrm>
            </p:grpSpPr>
            <p:sp>
              <p:nvSpPr>
                <p:cNvPr id="73" name=""/>
                <p:cNvSpPr/>
                <p:nvPr/>
              </p:nvSpPr>
              <p:spPr>
                <a:xfrm>
                  <a:off x="3290760" y="76320"/>
                  <a:ext cx="790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Arial"/>
                    </a:rPr>
                    <a:t>B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3290760" y="2046240"/>
                  <a:ext cx="790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Arial"/>
                    </a:rPr>
                    <a:t>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>
                  <a:off x="3290760" y="4030560"/>
                  <a:ext cx="790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200" spc="-1" strike="noStrike">
                      <a:solidFill>
                        <a:srgbClr val="000000"/>
                      </a:solidFill>
                      <a:latin typeface="Arial"/>
                    </a:rPr>
                    <a:t>F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Text Box 6"/>
                <p:cNvSpPr/>
                <p:nvPr/>
              </p:nvSpPr>
              <p:spPr>
                <a:xfrm rot="16200000">
                  <a:off x="3373560" y="964800"/>
                  <a:ext cx="10936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900" spc="-1" strike="noStrike">
                      <a:solidFill>
                        <a:srgbClr val="000000"/>
                      </a:solidFill>
                      <a:latin typeface="Arial"/>
                    </a:rPr>
                    <a:t>BAFF/</a:t>
                  </a:r>
                  <a:r>
                    <a:rPr b="0" lang="it-IT" sz="9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</a:t>
                  </a:r>
                  <a:r>
                    <a:rPr b="0" lang="it-IT" sz="900" spc="-1" strike="noStrike">
                      <a:solidFill>
                        <a:srgbClr val="000000"/>
                      </a:solidFill>
                      <a:latin typeface="Arial"/>
                    </a:rPr>
                    <a:t>-actin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Text Box 6"/>
                <p:cNvSpPr/>
                <p:nvPr/>
              </p:nvSpPr>
              <p:spPr>
                <a:xfrm rot="16200000">
                  <a:off x="3373200" y="2780280"/>
                  <a:ext cx="109404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900" spc="-1" strike="noStrike">
                      <a:solidFill>
                        <a:srgbClr val="000000"/>
                      </a:solidFill>
                      <a:latin typeface="Arial"/>
                    </a:rPr>
                    <a:t>CXCL-10/</a:t>
                  </a:r>
                  <a:r>
                    <a:rPr b="0" lang="it-IT" sz="9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</a:t>
                  </a:r>
                  <a:r>
                    <a:rPr b="0" lang="it-IT" sz="900" spc="-1" strike="noStrike">
                      <a:solidFill>
                        <a:srgbClr val="000000"/>
                      </a:solidFill>
                      <a:latin typeface="Arial"/>
                    </a:rPr>
                    <a:t>-actin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Text Box 6"/>
                <p:cNvSpPr/>
                <p:nvPr/>
              </p:nvSpPr>
              <p:spPr>
                <a:xfrm rot="16200000">
                  <a:off x="3373560" y="4533480"/>
                  <a:ext cx="109368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900" spc="-1" strike="noStrike">
                      <a:solidFill>
                        <a:srgbClr val="000000"/>
                      </a:solidFill>
                      <a:latin typeface="Arial"/>
                    </a:rPr>
                    <a:t>MxA/</a:t>
                  </a:r>
                  <a:r>
                    <a:rPr b="0" lang="it-IT" sz="9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</a:t>
                  </a:r>
                  <a:r>
                    <a:rPr b="0" lang="it-IT" sz="900" spc="-1" strike="noStrike">
                      <a:solidFill>
                        <a:srgbClr val="000000"/>
                      </a:solidFill>
                      <a:latin typeface="Arial"/>
                    </a:rPr>
                    <a:t>-actin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79" name=""/>
                <p:cNvGrpSpPr/>
                <p:nvPr/>
              </p:nvGrpSpPr>
              <p:grpSpPr>
                <a:xfrm>
                  <a:off x="4033440" y="133200"/>
                  <a:ext cx="2772000" cy="1765440"/>
                  <a:chOff x="4033440" y="133200"/>
                  <a:chExt cx="2772000" cy="1765440"/>
                </a:xfrm>
              </p:grpSpPr>
              <p:pic>
                <p:nvPicPr>
                  <p:cNvPr id="80" name="" descr=""/>
                  <p:cNvPicPr/>
                  <p:nvPr/>
                </p:nvPicPr>
                <p:blipFill>
                  <a:blip r:embed="rId4"/>
                  <a:srcRect l="0" t="7639" r="0" b="0"/>
                  <a:stretch/>
                </p:blipFill>
                <p:spPr>
                  <a:xfrm>
                    <a:off x="4033440" y="133200"/>
                    <a:ext cx="2772000" cy="176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81" name=""/>
                  <p:cNvSpPr/>
                  <p:nvPr/>
                </p:nvSpPr>
                <p:spPr>
                  <a:xfrm>
                    <a:off x="4106160" y="1732680"/>
                    <a:ext cx="2553120" cy="7308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26280" bIns="2628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82" name=""/>
                <p:cNvGrpSpPr/>
                <p:nvPr/>
              </p:nvGrpSpPr>
              <p:grpSpPr>
                <a:xfrm>
                  <a:off x="4033440" y="2084400"/>
                  <a:ext cx="2772000" cy="1751040"/>
                  <a:chOff x="4033440" y="2084400"/>
                  <a:chExt cx="2772000" cy="1751040"/>
                </a:xfrm>
              </p:grpSpPr>
              <p:pic>
                <p:nvPicPr>
                  <p:cNvPr id="83" name="" descr=""/>
                  <p:cNvPicPr/>
                  <p:nvPr/>
                </p:nvPicPr>
                <p:blipFill>
                  <a:blip r:embed="rId5"/>
                  <a:srcRect l="0" t="8352" r="0" b="0"/>
                  <a:stretch/>
                </p:blipFill>
                <p:spPr>
                  <a:xfrm>
                    <a:off x="4033440" y="2084400"/>
                    <a:ext cx="2772000" cy="1751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84" name=""/>
                  <p:cNvSpPr/>
                  <p:nvPr/>
                </p:nvSpPr>
                <p:spPr>
                  <a:xfrm>
                    <a:off x="4083480" y="3665160"/>
                    <a:ext cx="2553120" cy="7272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ffffff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25920" bIns="25920" anchor="ctr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85" name=""/>
                <p:cNvGrpSpPr/>
                <p:nvPr/>
              </p:nvGrpSpPr>
              <p:grpSpPr>
                <a:xfrm>
                  <a:off x="4033440" y="4021200"/>
                  <a:ext cx="2772000" cy="2302920"/>
                  <a:chOff x="4033440" y="4021200"/>
                  <a:chExt cx="2772000" cy="2302920"/>
                </a:xfrm>
              </p:grpSpPr>
              <p:grpSp>
                <p:nvGrpSpPr>
                  <p:cNvPr id="86" name=""/>
                  <p:cNvGrpSpPr/>
                  <p:nvPr/>
                </p:nvGrpSpPr>
                <p:grpSpPr>
                  <a:xfrm>
                    <a:off x="4033440" y="4021200"/>
                    <a:ext cx="2772000" cy="1763280"/>
                    <a:chOff x="4033440" y="4021200"/>
                    <a:chExt cx="2772000" cy="1763280"/>
                  </a:xfrm>
                </p:grpSpPr>
                <p:pic>
                  <p:nvPicPr>
                    <p:cNvPr id="87" name="" descr=""/>
                    <p:cNvPicPr/>
                    <p:nvPr/>
                  </p:nvPicPr>
                  <p:blipFill>
                    <a:blip r:embed="rId6"/>
                    <a:srcRect l="0" t="7639" r="0" b="0"/>
                    <a:stretch/>
                  </p:blipFill>
                  <p:spPr>
                    <a:xfrm>
                      <a:off x="4033440" y="4021200"/>
                      <a:ext cx="2772000" cy="1763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88" name=""/>
                    <p:cNvSpPr/>
                    <p:nvPr/>
                  </p:nvSpPr>
                  <p:spPr>
                    <a:xfrm>
                      <a:off x="4078800" y="5623560"/>
                      <a:ext cx="2553120" cy="72720"/>
                    </a:xfrm>
                    <a:prstGeom prst="rect">
                      <a:avLst/>
                    </a:prstGeom>
                    <a:solidFill>
                      <a:srgbClr val="ffffff"/>
                    </a:solidFill>
                    <a:ln w="9360">
                      <a:solidFill>
                        <a:srgbClr val="ffffff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25920" bIns="25920" anchor="ctr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89" name=""/>
                  <p:cNvGrpSpPr/>
                  <p:nvPr/>
                </p:nvGrpSpPr>
                <p:grpSpPr>
                  <a:xfrm>
                    <a:off x="4478040" y="5384520"/>
                    <a:ext cx="2043000" cy="939600"/>
                    <a:chOff x="4478040" y="5384520"/>
                    <a:chExt cx="2043000" cy="939600"/>
                  </a:xfrm>
                </p:grpSpPr>
                <p:sp>
                  <p:nvSpPr>
                    <p:cNvPr id="90" name="Text Box 251"/>
                    <p:cNvSpPr/>
                    <p:nvPr/>
                  </p:nvSpPr>
                  <p:spPr>
                    <a:xfrm rot="16200000">
                      <a:off x="4322880" y="5952600"/>
                      <a:ext cx="52596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 T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1" name="Text Box 252"/>
                    <p:cNvSpPr/>
                    <p:nvPr/>
                  </p:nvSpPr>
                  <p:spPr>
                    <a:xfrm rot="16200000">
                      <a:off x="4335120" y="5796000"/>
                      <a:ext cx="83556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 T0+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2" name="Text Box 253"/>
                    <p:cNvSpPr/>
                    <p:nvPr/>
                  </p:nvSpPr>
                  <p:spPr>
                    <a:xfrm rot="16200000">
                      <a:off x="4503600" y="5794560"/>
                      <a:ext cx="83556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 T1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3" name="Text Box 254"/>
                    <p:cNvSpPr/>
                    <p:nvPr/>
                  </p:nvSpPr>
                  <p:spPr>
                    <a:xfrm rot="16200000">
                      <a:off x="4613400" y="5746680"/>
                      <a:ext cx="93780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 T1m+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4" name="Text Box 255"/>
                    <p:cNvSpPr/>
                    <p:nvPr/>
                  </p:nvSpPr>
                  <p:spPr>
                    <a:xfrm rot="16200000">
                      <a:off x="4986720" y="5952600"/>
                      <a:ext cx="52596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 T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5" name="Text Box 256"/>
                    <p:cNvSpPr/>
                    <p:nvPr/>
                  </p:nvSpPr>
                  <p:spPr>
                    <a:xfrm rot="16200000">
                      <a:off x="4997160" y="5796000"/>
                      <a:ext cx="83556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 T0+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6" name="Text Box 257"/>
                    <p:cNvSpPr/>
                    <p:nvPr/>
                  </p:nvSpPr>
                  <p:spPr>
                    <a:xfrm rot="16200000">
                      <a:off x="5162760" y="5796000"/>
                      <a:ext cx="83556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 T1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7" name="Text Box 258"/>
                    <p:cNvSpPr/>
                    <p:nvPr/>
                  </p:nvSpPr>
                  <p:spPr>
                    <a:xfrm rot="16200000">
                      <a:off x="5274720" y="5746320"/>
                      <a:ext cx="93960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 T1m+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8" name="Text Box 259"/>
                    <p:cNvSpPr/>
                    <p:nvPr/>
                  </p:nvSpPr>
                  <p:spPr>
                    <a:xfrm rot="16200000">
                      <a:off x="5653440" y="5952600"/>
                      <a:ext cx="52596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 T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99" name="Text Box 260"/>
                    <p:cNvSpPr/>
                    <p:nvPr/>
                  </p:nvSpPr>
                  <p:spPr>
                    <a:xfrm rot="16200000">
                      <a:off x="5662440" y="5797800"/>
                      <a:ext cx="83592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 T0+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0" name="Text Box 261"/>
                    <p:cNvSpPr/>
                    <p:nvPr/>
                  </p:nvSpPr>
                  <p:spPr>
                    <a:xfrm rot="16200000">
                      <a:off x="5826240" y="5797800"/>
                      <a:ext cx="83592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 T1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01" name="Text Box 262"/>
                    <p:cNvSpPr/>
                    <p:nvPr/>
                  </p:nvSpPr>
                  <p:spPr>
                    <a:xfrm rot="16200000">
                      <a:off x="5944320" y="5746680"/>
                      <a:ext cx="937800" cy="21564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49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 T1m+2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</p:grpSp>
        <p:grpSp>
          <p:nvGrpSpPr>
            <p:cNvPr id="102" name=""/>
            <p:cNvGrpSpPr/>
            <p:nvPr/>
          </p:nvGrpSpPr>
          <p:grpSpPr>
            <a:xfrm>
              <a:off x="1380960" y="585720"/>
              <a:ext cx="990360" cy="337320"/>
              <a:chOff x="1380960" y="585720"/>
              <a:chExt cx="990360" cy="337320"/>
            </a:xfrm>
          </p:grpSpPr>
          <p:sp>
            <p:nvSpPr>
              <p:cNvPr id="103" name=""/>
              <p:cNvSpPr/>
              <p:nvPr/>
            </p:nvSpPr>
            <p:spPr>
              <a:xfrm>
                <a:off x="1380960" y="585720"/>
                <a:ext cx="990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4" name=""/>
              <p:cNvGrpSpPr/>
              <p:nvPr/>
            </p:nvGrpSpPr>
            <p:grpSpPr>
              <a:xfrm>
                <a:off x="1566360" y="730080"/>
                <a:ext cx="583920" cy="27000"/>
                <a:chOff x="1566360" y="730080"/>
                <a:chExt cx="583920" cy="27000"/>
              </a:xfrm>
            </p:grpSpPr>
            <p:grpSp>
              <p:nvGrpSpPr>
                <p:cNvPr id="105" name=""/>
                <p:cNvGrpSpPr/>
                <p:nvPr/>
              </p:nvGrpSpPr>
              <p:grpSpPr>
                <a:xfrm>
                  <a:off x="1971360" y="730080"/>
                  <a:ext cx="178920" cy="27000"/>
                  <a:chOff x="1971360" y="730080"/>
                  <a:chExt cx="178920" cy="27000"/>
                </a:xfrm>
              </p:grpSpPr>
              <p:sp>
                <p:nvSpPr>
                  <p:cNvPr id="106" name=""/>
                  <p:cNvSpPr/>
                  <p:nvPr/>
                </p:nvSpPr>
                <p:spPr>
                  <a:xfrm>
                    <a:off x="2150280" y="73008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" name=""/>
                  <p:cNvSpPr/>
                  <p:nvPr/>
                </p:nvSpPr>
                <p:spPr>
                  <a:xfrm>
                    <a:off x="1971360" y="73008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08" name=""/>
                <p:cNvGrpSpPr/>
                <p:nvPr/>
              </p:nvGrpSpPr>
              <p:grpSpPr>
                <a:xfrm>
                  <a:off x="1566360" y="730080"/>
                  <a:ext cx="178920" cy="27000"/>
                  <a:chOff x="1566360" y="730080"/>
                  <a:chExt cx="178920" cy="27000"/>
                </a:xfrm>
              </p:grpSpPr>
              <p:sp>
                <p:nvSpPr>
                  <p:cNvPr id="109" name=""/>
                  <p:cNvSpPr/>
                  <p:nvPr/>
                </p:nvSpPr>
                <p:spPr>
                  <a:xfrm>
                    <a:off x="1566360" y="73008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" name=""/>
                  <p:cNvSpPr/>
                  <p:nvPr/>
                </p:nvSpPr>
                <p:spPr>
                  <a:xfrm flipH="1">
                    <a:off x="1566360" y="73008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111" name=""/>
            <p:cNvGrpSpPr/>
            <p:nvPr/>
          </p:nvGrpSpPr>
          <p:grpSpPr>
            <a:xfrm>
              <a:off x="2279520" y="114480"/>
              <a:ext cx="990360" cy="337320"/>
              <a:chOff x="2279520" y="114480"/>
              <a:chExt cx="990360" cy="337320"/>
            </a:xfrm>
          </p:grpSpPr>
          <p:sp>
            <p:nvSpPr>
              <p:cNvPr id="112" name=""/>
              <p:cNvSpPr/>
              <p:nvPr/>
            </p:nvSpPr>
            <p:spPr>
              <a:xfrm>
                <a:off x="2279520" y="114480"/>
                <a:ext cx="990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13" name=""/>
              <p:cNvGrpSpPr/>
              <p:nvPr/>
            </p:nvGrpSpPr>
            <p:grpSpPr>
              <a:xfrm>
                <a:off x="2464920" y="258480"/>
                <a:ext cx="583920" cy="26640"/>
                <a:chOff x="2464920" y="258480"/>
                <a:chExt cx="583920" cy="26640"/>
              </a:xfrm>
            </p:grpSpPr>
            <p:grpSp>
              <p:nvGrpSpPr>
                <p:cNvPr id="114" name=""/>
                <p:cNvGrpSpPr/>
                <p:nvPr/>
              </p:nvGrpSpPr>
              <p:grpSpPr>
                <a:xfrm>
                  <a:off x="2869920" y="258480"/>
                  <a:ext cx="178920" cy="26640"/>
                  <a:chOff x="2869920" y="258480"/>
                  <a:chExt cx="178920" cy="26640"/>
                </a:xfrm>
              </p:grpSpPr>
              <p:sp>
                <p:nvSpPr>
                  <p:cNvPr id="115" name=""/>
                  <p:cNvSpPr/>
                  <p:nvPr/>
                </p:nvSpPr>
                <p:spPr>
                  <a:xfrm>
                    <a:off x="3048840" y="258480"/>
                    <a:ext cx="0" cy="26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0160" bIns="-20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" name=""/>
                  <p:cNvSpPr/>
                  <p:nvPr/>
                </p:nvSpPr>
                <p:spPr>
                  <a:xfrm>
                    <a:off x="2869920" y="25848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17" name=""/>
                <p:cNvGrpSpPr/>
                <p:nvPr/>
              </p:nvGrpSpPr>
              <p:grpSpPr>
                <a:xfrm>
                  <a:off x="2464920" y="258480"/>
                  <a:ext cx="178920" cy="26640"/>
                  <a:chOff x="2464920" y="258480"/>
                  <a:chExt cx="178920" cy="26640"/>
                </a:xfrm>
              </p:grpSpPr>
              <p:sp>
                <p:nvSpPr>
                  <p:cNvPr id="118" name=""/>
                  <p:cNvSpPr/>
                  <p:nvPr/>
                </p:nvSpPr>
                <p:spPr>
                  <a:xfrm>
                    <a:off x="2464920" y="258480"/>
                    <a:ext cx="0" cy="266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0160" bIns="-201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" name=""/>
                  <p:cNvSpPr/>
                  <p:nvPr/>
                </p:nvSpPr>
                <p:spPr>
                  <a:xfrm flipH="1">
                    <a:off x="2464920" y="25848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120" name=""/>
            <p:cNvGrpSpPr/>
            <p:nvPr/>
          </p:nvGrpSpPr>
          <p:grpSpPr>
            <a:xfrm>
              <a:off x="1380960" y="2058840"/>
              <a:ext cx="990360" cy="337320"/>
              <a:chOff x="1380960" y="2058840"/>
              <a:chExt cx="990360" cy="337320"/>
            </a:xfrm>
          </p:grpSpPr>
          <p:sp>
            <p:nvSpPr>
              <p:cNvPr id="121" name=""/>
              <p:cNvSpPr/>
              <p:nvPr/>
            </p:nvSpPr>
            <p:spPr>
              <a:xfrm>
                <a:off x="1380960" y="2058840"/>
                <a:ext cx="990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22" name=""/>
              <p:cNvGrpSpPr/>
              <p:nvPr/>
            </p:nvGrpSpPr>
            <p:grpSpPr>
              <a:xfrm>
                <a:off x="1566360" y="2203200"/>
                <a:ext cx="583920" cy="27000"/>
                <a:chOff x="1566360" y="2203200"/>
                <a:chExt cx="583920" cy="27000"/>
              </a:xfrm>
            </p:grpSpPr>
            <p:grpSp>
              <p:nvGrpSpPr>
                <p:cNvPr id="123" name=""/>
                <p:cNvGrpSpPr/>
                <p:nvPr/>
              </p:nvGrpSpPr>
              <p:grpSpPr>
                <a:xfrm>
                  <a:off x="1971360" y="2203200"/>
                  <a:ext cx="178920" cy="27000"/>
                  <a:chOff x="1971360" y="2203200"/>
                  <a:chExt cx="178920" cy="27000"/>
                </a:xfrm>
              </p:grpSpPr>
              <p:sp>
                <p:nvSpPr>
                  <p:cNvPr id="124" name=""/>
                  <p:cNvSpPr/>
                  <p:nvPr/>
                </p:nvSpPr>
                <p:spPr>
                  <a:xfrm>
                    <a:off x="2150280" y="220320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" name=""/>
                  <p:cNvSpPr/>
                  <p:nvPr/>
                </p:nvSpPr>
                <p:spPr>
                  <a:xfrm>
                    <a:off x="1971360" y="220320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26" name=""/>
                <p:cNvGrpSpPr/>
                <p:nvPr/>
              </p:nvGrpSpPr>
              <p:grpSpPr>
                <a:xfrm>
                  <a:off x="1566360" y="2203200"/>
                  <a:ext cx="178920" cy="27000"/>
                  <a:chOff x="1566360" y="2203200"/>
                  <a:chExt cx="178920" cy="27000"/>
                </a:xfrm>
              </p:grpSpPr>
              <p:sp>
                <p:nvSpPr>
                  <p:cNvPr id="127" name=""/>
                  <p:cNvSpPr/>
                  <p:nvPr/>
                </p:nvSpPr>
                <p:spPr>
                  <a:xfrm>
                    <a:off x="1566360" y="220320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" name=""/>
                  <p:cNvSpPr/>
                  <p:nvPr/>
                </p:nvSpPr>
                <p:spPr>
                  <a:xfrm flipH="1">
                    <a:off x="1566360" y="220320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129" name=""/>
            <p:cNvGrpSpPr/>
            <p:nvPr/>
          </p:nvGrpSpPr>
          <p:grpSpPr>
            <a:xfrm>
              <a:off x="2279520" y="2057400"/>
              <a:ext cx="990360" cy="337320"/>
              <a:chOff x="2279520" y="2057400"/>
              <a:chExt cx="990360" cy="337320"/>
            </a:xfrm>
          </p:grpSpPr>
          <p:sp>
            <p:nvSpPr>
              <p:cNvPr id="130" name=""/>
              <p:cNvSpPr/>
              <p:nvPr/>
            </p:nvSpPr>
            <p:spPr>
              <a:xfrm>
                <a:off x="2279520" y="2057400"/>
                <a:ext cx="990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31" name=""/>
              <p:cNvGrpSpPr/>
              <p:nvPr/>
            </p:nvGrpSpPr>
            <p:grpSpPr>
              <a:xfrm>
                <a:off x="2464920" y="2201760"/>
                <a:ext cx="583920" cy="27000"/>
                <a:chOff x="2464920" y="2201760"/>
                <a:chExt cx="583920" cy="27000"/>
              </a:xfrm>
            </p:grpSpPr>
            <p:grpSp>
              <p:nvGrpSpPr>
                <p:cNvPr id="132" name=""/>
                <p:cNvGrpSpPr/>
                <p:nvPr/>
              </p:nvGrpSpPr>
              <p:grpSpPr>
                <a:xfrm>
                  <a:off x="2869920" y="2201760"/>
                  <a:ext cx="178920" cy="27000"/>
                  <a:chOff x="2869920" y="2201760"/>
                  <a:chExt cx="178920" cy="27000"/>
                </a:xfrm>
              </p:grpSpPr>
              <p:sp>
                <p:nvSpPr>
                  <p:cNvPr id="133" name=""/>
                  <p:cNvSpPr/>
                  <p:nvPr/>
                </p:nvSpPr>
                <p:spPr>
                  <a:xfrm>
                    <a:off x="3048840" y="220176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" name=""/>
                  <p:cNvSpPr/>
                  <p:nvPr/>
                </p:nvSpPr>
                <p:spPr>
                  <a:xfrm>
                    <a:off x="2869920" y="220176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35" name=""/>
                <p:cNvGrpSpPr/>
                <p:nvPr/>
              </p:nvGrpSpPr>
              <p:grpSpPr>
                <a:xfrm>
                  <a:off x="2464920" y="2201760"/>
                  <a:ext cx="178920" cy="27000"/>
                  <a:chOff x="2464920" y="2201760"/>
                  <a:chExt cx="178920" cy="27000"/>
                </a:xfrm>
              </p:grpSpPr>
              <p:sp>
                <p:nvSpPr>
                  <p:cNvPr id="136" name=""/>
                  <p:cNvSpPr/>
                  <p:nvPr/>
                </p:nvSpPr>
                <p:spPr>
                  <a:xfrm>
                    <a:off x="2464920" y="220176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"/>
                  <p:cNvSpPr/>
                  <p:nvPr/>
                </p:nvSpPr>
                <p:spPr>
                  <a:xfrm flipH="1">
                    <a:off x="2464920" y="220176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138" name=""/>
            <p:cNvGrpSpPr/>
            <p:nvPr/>
          </p:nvGrpSpPr>
          <p:grpSpPr>
            <a:xfrm>
              <a:off x="1380960" y="4002120"/>
              <a:ext cx="990360" cy="337320"/>
              <a:chOff x="1380960" y="4002120"/>
              <a:chExt cx="990360" cy="337320"/>
            </a:xfrm>
          </p:grpSpPr>
          <p:sp>
            <p:nvSpPr>
              <p:cNvPr id="139" name=""/>
              <p:cNvSpPr/>
              <p:nvPr/>
            </p:nvSpPr>
            <p:spPr>
              <a:xfrm>
                <a:off x="1380960" y="4002120"/>
                <a:ext cx="990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0" name=""/>
              <p:cNvGrpSpPr/>
              <p:nvPr/>
            </p:nvGrpSpPr>
            <p:grpSpPr>
              <a:xfrm>
                <a:off x="1566360" y="4146480"/>
                <a:ext cx="583920" cy="27000"/>
                <a:chOff x="1566360" y="4146480"/>
                <a:chExt cx="583920" cy="27000"/>
              </a:xfrm>
            </p:grpSpPr>
            <p:grpSp>
              <p:nvGrpSpPr>
                <p:cNvPr id="141" name=""/>
                <p:cNvGrpSpPr/>
                <p:nvPr/>
              </p:nvGrpSpPr>
              <p:grpSpPr>
                <a:xfrm>
                  <a:off x="1971360" y="4146480"/>
                  <a:ext cx="178920" cy="27000"/>
                  <a:chOff x="1971360" y="4146480"/>
                  <a:chExt cx="178920" cy="27000"/>
                </a:xfrm>
              </p:grpSpPr>
              <p:sp>
                <p:nvSpPr>
                  <p:cNvPr id="142" name=""/>
                  <p:cNvSpPr/>
                  <p:nvPr/>
                </p:nvSpPr>
                <p:spPr>
                  <a:xfrm>
                    <a:off x="2150280" y="414648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3" name=""/>
                  <p:cNvSpPr/>
                  <p:nvPr/>
                </p:nvSpPr>
                <p:spPr>
                  <a:xfrm>
                    <a:off x="1971360" y="414648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44" name=""/>
                <p:cNvGrpSpPr/>
                <p:nvPr/>
              </p:nvGrpSpPr>
              <p:grpSpPr>
                <a:xfrm>
                  <a:off x="1566360" y="4146480"/>
                  <a:ext cx="178920" cy="27000"/>
                  <a:chOff x="1566360" y="4146480"/>
                  <a:chExt cx="178920" cy="27000"/>
                </a:xfrm>
              </p:grpSpPr>
              <p:sp>
                <p:nvSpPr>
                  <p:cNvPr id="145" name=""/>
                  <p:cNvSpPr/>
                  <p:nvPr/>
                </p:nvSpPr>
                <p:spPr>
                  <a:xfrm>
                    <a:off x="1566360" y="414648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6" name=""/>
                  <p:cNvSpPr/>
                  <p:nvPr/>
                </p:nvSpPr>
                <p:spPr>
                  <a:xfrm flipH="1">
                    <a:off x="1566360" y="414648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147" name=""/>
            <p:cNvGrpSpPr/>
            <p:nvPr/>
          </p:nvGrpSpPr>
          <p:grpSpPr>
            <a:xfrm>
              <a:off x="2279520" y="4268880"/>
              <a:ext cx="990360" cy="337320"/>
              <a:chOff x="2279520" y="4268880"/>
              <a:chExt cx="990360" cy="337320"/>
            </a:xfrm>
          </p:grpSpPr>
          <p:sp>
            <p:nvSpPr>
              <p:cNvPr id="148" name=""/>
              <p:cNvSpPr/>
              <p:nvPr/>
            </p:nvSpPr>
            <p:spPr>
              <a:xfrm>
                <a:off x="2279520" y="4268880"/>
                <a:ext cx="990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9" name=""/>
              <p:cNvGrpSpPr/>
              <p:nvPr/>
            </p:nvGrpSpPr>
            <p:grpSpPr>
              <a:xfrm>
                <a:off x="2464920" y="4413240"/>
                <a:ext cx="583920" cy="27000"/>
                <a:chOff x="2464920" y="4413240"/>
                <a:chExt cx="583920" cy="27000"/>
              </a:xfrm>
            </p:grpSpPr>
            <p:grpSp>
              <p:nvGrpSpPr>
                <p:cNvPr id="150" name=""/>
                <p:cNvGrpSpPr/>
                <p:nvPr/>
              </p:nvGrpSpPr>
              <p:grpSpPr>
                <a:xfrm>
                  <a:off x="2869920" y="4413240"/>
                  <a:ext cx="178920" cy="27000"/>
                  <a:chOff x="2869920" y="4413240"/>
                  <a:chExt cx="178920" cy="27000"/>
                </a:xfrm>
              </p:grpSpPr>
              <p:sp>
                <p:nvSpPr>
                  <p:cNvPr id="151" name=""/>
                  <p:cNvSpPr/>
                  <p:nvPr/>
                </p:nvSpPr>
                <p:spPr>
                  <a:xfrm>
                    <a:off x="3048840" y="441324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2" name=""/>
                  <p:cNvSpPr/>
                  <p:nvPr/>
                </p:nvSpPr>
                <p:spPr>
                  <a:xfrm>
                    <a:off x="2869920" y="441324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53" name=""/>
                <p:cNvGrpSpPr/>
                <p:nvPr/>
              </p:nvGrpSpPr>
              <p:grpSpPr>
                <a:xfrm>
                  <a:off x="2464920" y="4413240"/>
                  <a:ext cx="178920" cy="27000"/>
                  <a:chOff x="2464920" y="4413240"/>
                  <a:chExt cx="178920" cy="27000"/>
                </a:xfrm>
              </p:grpSpPr>
              <p:sp>
                <p:nvSpPr>
                  <p:cNvPr id="154" name=""/>
                  <p:cNvSpPr/>
                  <p:nvPr/>
                </p:nvSpPr>
                <p:spPr>
                  <a:xfrm>
                    <a:off x="2464920" y="441324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5" name=""/>
                  <p:cNvSpPr/>
                  <p:nvPr/>
                </p:nvSpPr>
                <p:spPr>
                  <a:xfrm flipH="1">
                    <a:off x="2464920" y="4413240"/>
                    <a:ext cx="17892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156" name=""/>
            <p:cNvGrpSpPr/>
            <p:nvPr/>
          </p:nvGrpSpPr>
          <p:grpSpPr>
            <a:xfrm>
              <a:off x="5114880" y="76320"/>
              <a:ext cx="1326600" cy="1203840"/>
              <a:chOff x="5114880" y="76320"/>
              <a:chExt cx="1326600" cy="1203840"/>
            </a:xfrm>
          </p:grpSpPr>
          <p:grpSp>
            <p:nvGrpSpPr>
              <p:cNvPr id="157" name=""/>
              <p:cNvGrpSpPr/>
              <p:nvPr/>
            </p:nvGrpSpPr>
            <p:grpSpPr>
              <a:xfrm>
                <a:off x="5114880" y="942840"/>
                <a:ext cx="355320" cy="337320"/>
                <a:chOff x="5114880" y="942840"/>
                <a:chExt cx="355320" cy="337320"/>
              </a:xfrm>
            </p:grpSpPr>
            <p:sp>
              <p:nvSpPr>
                <p:cNvPr id="158" name=""/>
                <p:cNvSpPr/>
                <p:nvPr/>
              </p:nvSpPr>
              <p:spPr>
                <a:xfrm>
                  <a:off x="5114880" y="942840"/>
                  <a:ext cx="3553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59" name=""/>
                <p:cNvGrpSpPr/>
                <p:nvPr/>
              </p:nvGrpSpPr>
              <p:grpSpPr>
                <a:xfrm>
                  <a:off x="5180760" y="1087200"/>
                  <a:ext cx="210240" cy="27000"/>
                  <a:chOff x="5180760" y="1087200"/>
                  <a:chExt cx="210240" cy="27000"/>
                </a:xfrm>
              </p:grpSpPr>
              <p:grpSp>
                <p:nvGrpSpPr>
                  <p:cNvPr id="160" name=""/>
                  <p:cNvGrpSpPr/>
                  <p:nvPr/>
                </p:nvGrpSpPr>
                <p:grpSpPr>
                  <a:xfrm>
                    <a:off x="5326560" y="1087200"/>
                    <a:ext cx="64440" cy="27000"/>
                    <a:chOff x="5326560" y="1087200"/>
                    <a:chExt cx="64440" cy="27000"/>
                  </a:xfrm>
                </p:grpSpPr>
                <p:sp>
                  <p:nvSpPr>
                    <p:cNvPr id="161" name=""/>
                    <p:cNvSpPr/>
                    <p:nvPr/>
                  </p:nvSpPr>
                  <p:spPr>
                    <a:xfrm>
                      <a:off x="5391000" y="108720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2" name=""/>
                    <p:cNvSpPr/>
                    <p:nvPr/>
                  </p:nvSpPr>
                  <p:spPr>
                    <a:xfrm>
                      <a:off x="5326560" y="108720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63" name=""/>
                  <p:cNvGrpSpPr/>
                  <p:nvPr/>
                </p:nvGrpSpPr>
                <p:grpSpPr>
                  <a:xfrm>
                    <a:off x="5180760" y="1087200"/>
                    <a:ext cx="64440" cy="27000"/>
                    <a:chOff x="5180760" y="1087200"/>
                    <a:chExt cx="64440" cy="27000"/>
                  </a:xfrm>
                </p:grpSpPr>
                <p:sp>
                  <p:nvSpPr>
                    <p:cNvPr id="164" name=""/>
                    <p:cNvSpPr/>
                    <p:nvPr/>
                  </p:nvSpPr>
                  <p:spPr>
                    <a:xfrm>
                      <a:off x="5180760" y="108720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65" name=""/>
                    <p:cNvSpPr/>
                    <p:nvPr/>
                  </p:nvSpPr>
                  <p:spPr>
                    <a:xfrm flipH="1">
                      <a:off x="5180760" y="108720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166" name=""/>
              <p:cNvGrpSpPr/>
              <p:nvPr/>
            </p:nvGrpSpPr>
            <p:grpSpPr>
              <a:xfrm>
                <a:off x="5432040" y="76320"/>
                <a:ext cx="355320" cy="337320"/>
                <a:chOff x="5432040" y="76320"/>
                <a:chExt cx="355320" cy="337320"/>
              </a:xfrm>
            </p:grpSpPr>
            <p:sp>
              <p:nvSpPr>
                <p:cNvPr id="167" name=""/>
                <p:cNvSpPr/>
                <p:nvPr/>
              </p:nvSpPr>
              <p:spPr>
                <a:xfrm>
                  <a:off x="5432040" y="76320"/>
                  <a:ext cx="3553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68" name=""/>
                <p:cNvGrpSpPr/>
                <p:nvPr/>
              </p:nvGrpSpPr>
              <p:grpSpPr>
                <a:xfrm>
                  <a:off x="5497920" y="220680"/>
                  <a:ext cx="210240" cy="27000"/>
                  <a:chOff x="5497920" y="220680"/>
                  <a:chExt cx="210240" cy="27000"/>
                </a:xfrm>
              </p:grpSpPr>
              <p:grpSp>
                <p:nvGrpSpPr>
                  <p:cNvPr id="169" name=""/>
                  <p:cNvGrpSpPr/>
                  <p:nvPr/>
                </p:nvGrpSpPr>
                <p:grpSpPr>
                  <a:xfrm>
                    <a:off x="5643720" y="220680"/>
                    <a:ext cx="64440" cy="27000"/>
                    <a:chOff x="5643720" y="220680"/>
                    <a:chExt cx="64440" cy="27000"/>
                  </a:xfrm>
                </p:grpSpPr>
                <p:sp>
                  <p:nvSpPr>
                    <p:cNvPr id="170" name=""/>
                    <p:cNvSpPr/>
                    <p:nvPr/>
                  </p:nvSpPr>
                  <p:spPr>
                    <a:xfrm>
                      <a:off x="5708160" y="22068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1" name=""/>
                    <p:cNvSpPr/>
                    <p:nvPr/>
                  </p:nvSpPr>
                  <p:spPr>
                    <a:xfrm>
                      <a:off x="5643720" y="22068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72" name=""/>
                  <p:cNvGrpSpPr/>
                  <p:nvPr/>
                </p:nvGrpSpPr>
                <p:grpSpPr>
                  <a:xfrm>
                    <a:off x="5497920" y="220680"/>
                    <a:ext cx="64440" cy="27000"/>
                    <a:chOff x="5497920" y="220680"/>
                    <a:chExt cx="64440" cy="27000"/>
                  </a:xfrm>
                </p:grpSpPr>
                <p:sp>
                  <p:nvSpPr>
                    <p:cNvPr id="173" name=""/>
                    <p:cNvSpPr/>
                    <p:nvPr/>
                  </p:nvSpPr>
                  <p:spPr>
                    <a:xfrm>
                      <a:off x="5497920" y="22068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74" name=""/>
                    <p:cNvSpPr/>
                    <p:nvPr/>
                  </p:nvSpPr>
                  <p:spPr>
                    <a:xfrm flipH="1">
                      <a:off x="5497920" y="22068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175" name=""/>
              <p:cNvGrpSpPr/>
              <p:nvPr/>
            </p:nvGrpSpPr>
            <p:grpSpPr>
              <a:xfrm>
                <a:off x="5743440" y="942840"/>
                <a:ext cx="354960" cy="337320"/>
                <a:chOff x="5743440" y="942840"/>
                <a:chExt cx="354960" cy="337320"/>
              </a:xfrm>
            </p:grpSpPr>
            <p:sp>
              <p:nvSpPr>
                <p:cNvPr id="176" name=""/>
                <p:cNvSpPr/>
                <p:nvPr/>
              </p:nvSpPr>
              <p:spPr>
                <a:xfrm>
                  <a:off x="5743440" y="942840"/>
                  <a:ext cx="35496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77" name=""/>
                <p:cNvGrpSpPr/>
                <p:nvPr/>
              </p:nvGrpSpPr>
              <p:grpSpPr>
                <a:xfrm>
                  <a:off x="5809680" y="1087200"/>
                  <a:ext cx="209160" cy="27000"/>
                  <a:chOff x="5809680" y="1087200"/>
                  <a:chExt cx="209160" cy="27000"/>
                </a:xfrm>
              </p:grpSpPr>
              <p:grpSp>
                <p:nvGrpSpPr>
                  <p:cNvPr id="178" name=""/>
                  <p:cNvGrpSpPr/>
                  <p:nvPr/>
                </p:nvGrpSpPr>
                <p:grpSpPr>
                  <a:xfrm>
                    <a:off x="5954760" y="1087200"/>
                    <a:ext cx="64080" cy="27000"/>
                    <a:chOff x="5954760" y="1087200"/>
                    <a:chExt cx="64080" cy="27000"/>
                  </a:xfrm>
                </p:grpSpPr>
                <p:sp>
                  <p:nvSpPr>
                    <p:cNvPr id="179" name=""/>
                    <p:cNvSpPr/>
                    <p:nvPr/>
                  </p:nvSpPr>
                  <p:spPr>
                    <a:xfrm>
                      <a:off x="6018840" y="108720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0" name=""/>
                    <p:cNvSpPr/>
                    <p:nvPr/>
                  </p:nvSpPr>
                  <p:spPr>
                    <a:xfrm>
                      <a:off x="5954760" y="1087200"/>
                      <a:ext cx="6408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81" name=""/>
                  <p:cNvGrpSpPr/>
                  <p:nvPr/>
                </p:nvGrpSpPr>
                <p:grpSpPr>
                  <a:xfrm>
                    <a:off x="5809680" y="1087200"/>
                    <a:ext cx="64080" cy="27000"/>
                    <a:chOff x="5809680" y="1087200"/>
                    <a:chExt cx="64080" cy="27000"/>
                  </a:xfrm>
                </p:grpSpPr>
                <p:sp>
                  <p:nvSpPr>
                    <p:cNvPr id="182" name=""/>
                    <p:cNvSpPr/>
                    <p:nvPr/>
                  </p:nvSpPr>
                  <p:spPr>
                    <a:xfrm>
                      <a:off x="5809680" y="108720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3" name=""/>
                    <p:cNvSpPr/>
                    <p:nvPr/>
                  </p:nvSpPr>
                  <p:spPr>
                    <a:xfrm flipH="1">
                      <a:off x="5809680" y="1087200"/>
                      <a:ext cx="6408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184" name=""/>
              <p:cNvGrpSpPr/>
              <p:nvPr/>
            </p:nvGrpSpPr>
            <p:grpSpPr>
              <a:xfrm>
                <a:off x="6086160" y="669960"/>
                <a:ext cx="355320" cy="337320"/>
                <a:chOff x="6086160" y="669960"/>
                <a:chExt cx="355320" cy="337320"/>
              </a:xfrm>
            </p:grpSpPr>
            <p:sp>
              <p:nvSpPr>
                <p:cNvPr id="185" name=""/>
                <p:cNvSpPr/>
                <p:nvPr/>
              </p:nvSpPr>
              <p:spPr>
                <a:xfrm>
                  <a:off x="6086160" y="669960"/>
                  <a:ext cx="3553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86" name=""/>
                <p:cNvGrpSpPr/>
                <p:nvPr/>
              </p:nvGrpSpPr>
              <p:grpSpPr>
                <a:xfrm>
                  <a:off x="6152040" y="814320"/>
                  <a:ext cx="210240" cy="27000"/>
                  <a:chOff x="6152040" y="814320"/>
                  <a:chExt cx="210240" cy="27000"/>
                </a:xfrm>
              </p:grpSpPr>
              <p:grpSp>
                <p:nvGrpSpPr>
                  <p:cNvPr id="187" name=""/>
                  <p:cNvGrpSpPr/>
                  <p:nvPr/>
                </p:nvGrpSpPr>
                <p:grpSpPr>
                  <a:xfrm>
                    <a:off x="6297840" y="814320"/>
                    <a:ext cx="64440" cy="27000"/>
                    <a:chOff x="6297840" y="814320"/>
                    <a:chExt cx="64440" cy="27000"/>
                  </a:xfrm>
                </p:grpSpPr>
                <p:sp>
                  <p:nvSpPr>
                    <p:cNvPr id="188" name=""/>
                    <p:cNvSpPr/>
                    <p:nvPr/>
                  </p:nvSpPr>
                  <p:spPr>
                    <a:xfrm>
                      <a:off x="6362280" y="81432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89" name=""/>
                    <p:cNvSpPr/>
                    <p:nvPr/>
                  </p:nvSpPr>
                  <p:spPr>
                    <a:xfrm>
                      <a:off x="6297840" y="81432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190" name=""/>
                  <p:cNvGrpSpPr/>
                  <p:nvPr/>
                </p:nvGrpSpPr>
                <p:grpSpPr>
                  <a:xfrm>
                    <a:off x="6152040" y="814320"/>
                    <a:ext cx="64440" cy="27000"/>
                    <a:chOff x="6152040" y="814320"/>
                    <a:chExt cx="64440" cy="27000"/>
                  </a:xfrm>
                </p:grpSpPr>
                <p:sp>
                  <p:nvSpPr>
                    <p:cNvPr id="191" name=""/>
                    <p:cNvSpPr/>
                    <p:nvPr/>
                  </p:nvSpPr>
                  <p:spPr>
                    <a:xfrm>
                      <a:off x="6152040" y="81432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192" name=""/>
                    <p:cNvSpPr/>
                    <p:nvPr/>
                  </p:nvSpPr>
                  <p:spPr>
                    <a:xfrm flipH="1">
                      <a:off x="6152040" y="81432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</p:grpSp>
        <p:grpSp>
          <p:nvGrpSpPr>
            <p:cNvPr id="193" name=""/>
            <p:cNvGrpSpPr/>
            <p:nvPr/>
          </p:nvGrpSpPr>
          <p:grpSpPr>
            <a:xfrm>
              <a:off x="5140080" y="2308320"/>
              <a:ext cx="355680" cy="337320"/>
              <a:chOff x="5140080" y="2308320"/>
              <a:chExt cx="355680" cy="337320"/>
            </a:xfrm>
          </p:grpSpPr>
          <p:sp>
            <p:nvSpPr>
              <p:cNvPr id="194" name=""/>
              <p:cNvSpPr/>
              <p:nvPr/>
            </p:nvSpPr>
            <p:spPr>
              <a:xfrm>
                <a:off x="5140080" y="2308320"/>
                <a:ext cx="3556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95" name=""/>
              <p:cNvGrpSpPr/>
              <p:nvPr/>
            </p:nvGrpSpPr>
            <p:grpSpPr>
              <a:xfrm>
                <a:off x="5205960" y="2452680"/>
                <a:ext cx="210240" cy="27000"/>
                <a:chOff x="5205960" y="2452680"/>
                <a:chExt cx="210240" cy="27000"/>
              </a:xfrm>
            </p:grpSpPr>
            <p:grpSp>
              <p:nvGrpSpPr>
                <p:cNvPr id="196" name=""/>
                <p:cNvGrpSpPr/>
                <p:nvPr/>
              </p:nvGrpSpPr>
              <p:grpSpPr>
                <a:xfrm>
                  <a:off x="5351760" y="2452680"/>
                  <a:ext cx="64440" cy="27000"/>
                  <a:chOff x="5351760" y="2452680"/>
                  <a:chExt cx="64440" cy="27000"/>
                </a:xfrm>
              </p:grpSpPr>
              <p:sp>
                <p:nvSpPr>
                  <p:cNvPr id="197" name=""/>
                  <p:cNvSpPr/>
                  <p:nvPr/>
                </p:nvSpPr>
                <p:spPr>
                  <a:xfrm>
                    <a:off x="5416200" y="245268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8" name=""/>
                  <p:cNvSpPr/>
                  <p:nvPr/>
                </p:nvSpPr>
                <p:spPr>
                  <a:xfrm>
                    <a:off x="5351760" y="2452680"/>
                    <a:ext cx="64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99" name=""/>
                <p:cNvGrpSpPr/>
                <p:nvPr/>
              </p:nvGrpSpPr>
              <p:grpSpPr>
                <a:xfrm>
                  <a:off x="5205960" y="2452680"/>
                  <a:ext cx="64440" cy="27000"/>
                  <a:chOff x="5205960" y="2452680"/>
                  <a:chExt cx="64440" cy="27000"/>
                </a:xfrm>
              </p:grpSpPr>
              <p:sp>
                <p:nvSpPr>
                  <p:cNvPr id="200" name=""/>
                  <p:cNvSpPr/>
                  <p:nvPr/>
                </p:nvSpPr>
                <p:spPr>
                  <a:xfrm>
                    <a:off x="5205960" y="245268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1" name=""/>
                  <p:cNvSpPr/>
                  <p:nvPr/>
                </p:nvSpPr>
                <p:spPr>
                  <a:xfrm flipH="1">
                    <a:off x="5205960" y="2452680"/>
                    <a:ext cx="64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202" name=""/>
            <p:cNvGrpSpPr/>
            <p:nvPr/>
          </p:nvGrpSpPr>
          <p:grpSpPr>
            <a:xfrm>
              <a:off x="5445000" y="1990800"/>
              <a:ext cx="355680" cy="337320"/>
              <a:chOff x="5445000" y="1990800"/>
              <a:chExt cx="355680" cy="337320"/>
            </a:xfrm>
          </p:grpSpPr>
          <p:sp>
            <p:nvSpPr>
              <p:cNvPr id="203" name=""/>
              <p:cNvSpPr/>
              <p:nvPr/>
            </p:nvSpPr>
            <p:spPr>
              <a:xfrm>
                <a:off x="5445000" y="1990800"/>
                <a:ext cx="3556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04" name=""/>
              <p:cNvGrpSpPr/>
              <p:nvPr/>
            </p:nvGrpSpPr>
            <p:grpSpPr>
              <a:xfrm>
                <a:off x="5510880" y="2135160"/>
                <a:ext cx="210240" cy="27000"/>
                <a:chOff x="5510880" y="2135160"/>
                <a:chExt cx="210240" cy="27000"/>
              </a:xfrm>
            </p:grpSpPr>
            <p:grpSp>
              <p:nvGrpSpPr>
                <p:cNvPr id="205" name=""/>
                <p:cNvGrpSpPr/>
                <p:nvPr/>
              </p:nvGrpSpPr>
              <p:grpSpPr>
                <a:xfrm>
                  <a:off x="5656680" y="2135160"/>
                  <a:ext cx="64440" cy="27000"/>
                  <a:chOff x="5656680" y="2135160"/>
                  <a:chExt cx="64440" cy="27000"/>
                </a:xfrm>
              </p:grpSpPr>
              <p:sp>
                <p:nvSpPr>
                  <p:cNvPr id="206" name=""/>
                  <p:cNvSpPr/>
                  <p:nvPr/>
                </p:nvSpPr>
                <p:spPr>
                  <a:xfrm>
                    <a:off x="5721120" y="213516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7" name=""/>
                  <p:cNvSpPr/>
                  <p:nvPr/>
                </p:nvSpPr>
                <p:spPr>
                  <a:xfrm>
                    <a:off x="5656680" y="2135160"/>
                    <a:ext cx="64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08" name=""/>
                <p:cNvGrpSpPr/>
                <p:nvPr/>
              </p:nvGrpSpPr>
              <p:grpSpPr>
                <a:xfrm>
                  <a:off x="5510880" y="2135160"/>
                  <a:ext cx="64440" cy="27000"/>
                  <a:chOff x="5510880" y="2135160"/>
                  <a:chExt cx="64440" cy="27000"/>
                </a:xfrm>
              </p:grpSpPr>
              <p:sp>
                <p:nvSpPr>
                  <p:cNvPr id="209" name=""/>
                  <p:cNvSpPr/>
                  <p:nvPr/>
                </p:nvSpPr>
                <p:spPr>
                  <a:xfrm>
                    <a:off x="5510880" y="213516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0" name=""/>
                  <p:cNvSpPr/>
                  <p:nvPr/>
                </p:nvSpPr>
                <p:spPr>
                  <a:xfrm flipH="1">
                    <a:off x="5510880" y="2135160"/>
                    <a:ext cx="64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211" name=""/>
            <p:cNvGrpSpPr/>
            <p:nvPr/>
          </p:nvGrpSpPr>
          <p:grpSpPr>
            <a:xfrm>
              <a:off x="5769000" y="2308320"/>
              <a:ext cx="355320" cy="337320"/>
              <a:chOff x="5769000" y="2308320"/>
              <a:chExt cx="355320" cy="337320"/>
            </a:xfrm>
          </p:grpSpPr>
          <p:sp>
            <p:nvSpPr>
              <p:cNvPr id="212" name=""/>
              <p:cNvSpPr/>
              <p:nvPr/>
            </p:nvSpPr>
            <p:spPr>
              <a:xfrm>
                <a:off x="5769000" y="2308320"/>
                <a:ext cx="3553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13" name=""/>
              <p:cNvGrpSpPr/>
              <p:nvPr/>
            </p:nvGrpSpPr>
            <p:grpSpPr>
              <a:xfrm>
                <a:off x="5834880" y="2452680"/>
                <a:ext cx="210240" cy="27000"/>
                <a:chOff x="5834880" y="2452680"/>
                <a:chExt cx="210240" cy="27000"/>
              </a:xfrm>
            </p:grpSpPr>
            <p:grpSp>
              <p:nvGrpSpPr>
                <p:cNvPr id="214" name=""/>
                <p:cNvGrpSpPr/>
                <p:nvPr/>
              </p:nvGrpSpPr>
              <p:grpSpPr>
                <a:xfrm>
                  <a:off x="5980680" y="2452680"/>
                  <a:ext cx="64440" cy="27000"/>
                  <a:chOff x="5980680" y="2452680"/>
                  <a:chExt cx="64440" cy="27000"/>
                </a:xfrm>
              </p:grpSpPr>
              <p:sp>
                <p:nvSpPr>
                  <p:cNvPr id="215" name=""/>
                  <p:cNvSpPr/>
                  <p:nvPr/>
                </p:nvSpPr>
                <p:spPr>
                  <a:xfrm>
                    <a:off x="6045120" y="245268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6" name=""/>
                  <p:cNvSpPr/>
                  <p:nvPr/>
                </p:nvSpPr>
                <p:spPr>
                  <a:xfrm>
                    <a:off x="5980680" y="2452680"/>
                    <a:ext cx="64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17" name=""/>
                <p:cNvGrpSpPr/>
                <p:nvPr/>
              </p:nvGrpSpPr>
              <p:grpSpPr>
                <a:xfrm>
                  <a:off x="5834880" y="2452680"/>
                  <a:ext cx="64440" cy="27000"/>
                  <a:chOff x="5834880" y="2452680"/>
                  <a:chExt cx="64440" cy="27000"/>
                </a:xfrm>
              </p:grpSpPr>
              <p:sp>
                <p:nvSpPr>
                  <p:cNvPr id="218" name=""/>
                  <p:cNvSpPr/>
                  <p:nvPr/>
                </p:nvSpPr>
                <p:spPr>
                  <a:xfrm>
                    <a:off x="5834880" y="245268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9" name=""/>
                  <p:cNvSpPr/>
                  <p:nvPr/>
                </p:nvSpPr>
                <p:spPr>
                  <a:xfrm flipH="1">
                    <a:off x="5834880" y="2452680"/>
                    <a:ext cx="64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220" name=""/>
            <p:cNvGrpSpPr/>
            <p:nvPr/>
          </p:nvGrpSpPr>
          <p:grpSpPr>
            <a:xfrm>
              <a:off x="6111720" y="2668680"/>
              <a:ext cx="355680" cy="337320"/>
              <a:chOff x="6111720" y="2668680"/>
              <a:chExt cx="355680" cy="337320"/>
            </a:xfrm>
          </p:grpSpPr>
          <p:sp>
            <p:nvSpPr>
              <p:cNvPr id="221" name=""/>
              <p:cNvSpPr/>
              <p:nvPr/>
            </p:nvSpPr>
            <p:spPr>
              <a:xfrm>
                <a:off x="6111720" y="2668680"/>
                <a:ext cx="35568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22" name=""/>
              <p:cNvGrpSpPr/>
              <p:nvPr/>
            </p:nvGrpSpPr>
            <p:grpSpPr>
              <a:xfrm>
                <a:off x="6177600" y="2813040"/>
                <a:ext cx="210240" cy="27000"/>
                <a:chOff x="6177600" y="2813040"/>
                <a:chExt cx="210240" cy="27000"/>
              </a:xfrm>
            </p:grpSpPr>
            <p:grpSp>
              <p:nvGrpSpPr>
                <p:cNvPr id="223" name=""/>
                <p:cNvGrpSpPr/>
                <p:nvPr/>
              </p:nvGrpSpPr>
              <p:grpSpPr>
                <a:xfrm>
                  <a:off x="6323400" y="2813040"/>
                  <a:ext cx="64440" cy="27000"/>
                  <a:chOff x="6323400" y="2813040"/>
                  <a:chExt cx="64440" cy="27000"/>
                </a:xfrm>
              </p:grpSpPr>
              <p:sp>
                <p:nvSpPr>
                  <p:cNvPr id="224" name=""/>
                  <p:cNvSpPr/>
                  <p:nvPr/>
                </p:nvSpPr>
                <p:spPr>
                  <a:xfrm>
                    <a:off x="6387840" y="281304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5" name=""/>
                  <p:cNvSpPr/>
                  <p:nvPr/>
                </p:nvSpPr>
                <p:spPr>
                  <a:xfrm>
                    <a:off x="6323400" y="2813040"/>
                    <a:ext cx="64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26" name=""/>
                <p:cNvGrpSpPr/>
                <p:nvPr/>
              </p:nvGrpSpPr>
              <p:grpSpPr>
                <a:xfrm>
                  <a:off x="6177600" y="2813040"/>
                  <a:ext cx="64440" cy="27000"/>
                  <a:chOff x="6177600" y="2813040"/>
                  <a:chExt cx="64440" cy="27000"/>
                </a:xfrm>
              </p:grpSpPr>
              <p:sp>
                <p:nvSpPr>
                  <p:cNvPr id="227" name=""/>
                  <p:cNvSpPr/>
                  <p:nvPr/>
                </p:nvSpPr>
                <p:spPr>
                  <a:xfrm>
                    <a:off x="6177600" y="2813040"/>
                    <a:ext cx="0" cy="27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9800" bIns="-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8" name=""/>
                  <p:cNvSpPr/>
                  <p:nvPr/>
                </p:nvSpPr>
                <p:spPr>
                  <a:xfrm flipH="1">
                    <a:off x="6177600" y="2813040"/>
                    <a:ext cx="644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229" name=""/>
            <p:cNvGrpSpPr/>
            <p:nvPr/>
          </p:nvGrpSpPr>
          <p:grpSpPr>
            <a:xfrm>
              <a:off x="5124240" y="3973680"/>
              <a:ext cx="1326960" cy="826200"/>
              <a:chOff x="5124240" y="3973680"/>
              <a:chExt cx="1326960" cy="826200"/>
            </a:xfrm>
          </p:grpSpPr>
          <p:grpSp>
            <p:nvGrpSpPr>
              <p:cNvPr id="230" name=""/>
              <p:cNvGrpSpPr/>
              <p:nvPr/>
            </p:nvGrpSpPr>
            <p:grpSpPr>
              <a:xfrm>
                <a:off x="5124240" y="4257720"/>
                <a:ext cx="355680" cy="337320"/>
                <a:chOff x="5124240" y="4257720"/>
                <a:chExt cx="355680" cy="337320"/>
              </a:xfrm>
            </p:grpSpPr>
            <p:sp>
              <p:nvSpPr>
                <p:cNvPr id="231" name=""/>
                <p:cNvSpPr/>
                <p:nvPr/>
              </p:nvSpPr>
              <p:spPr>
                <a:xfrm>
                  <a:off x="5124240" y="4257720"/>
                  <a:ext cx="3556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32" name=""/>
                <p:cNvGrpSpPr/>
                <p:nvPr/>
              </p:nvGrpSpPr>
              <p:grpSpPr>
                <a:xfrm>
                  <a:off x="5190120" y="4402080"/>
                  <a:ext cx="210240" cy="27000"/>
                  <a:chOff x="5190120" y="4402080"/>
                  <a:chExt cx="210240" cy="27000"/>
                </a:xfrm>
              </p:grpSpPr>
              <p:grpSp>
                <p:nvGrpSpPr>
                  <p:cNvPr id="233" name=""/>
                  <p:cNvGrpSpPr/>
                  <p:nvPr/>
                </p:nvGrpSpPr>
                <p:grpSpPr>
                  <a:xfrm>
                    <a:off x="5335920" y="4402080"/>
                    <a:ext cx="64440" cy="27000"/>
                    <a:chOff x="5335920" y="4402080"/>
                    <a:chExt cx="64440" cy="27000"/>
                  </a:xfrm>
                </p:grpSpPr>
                <p:sp>
                  <p:nvSpPr>
                    <p:cNvPr id="234" name=""/>
                    <p:cNvSpPr/>
                    <p:nvPr/>
                  </p:nvSpPr>
                  <p:spPr>
                    <a:xfrm>
                      <a:off x="5400360" y="440208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5" name=""/>
                    <p:cNvSpPr/>
                    <p:nvPr/>
                  </p:nvSpPr>
                  <p:spPr>
                    <a:xfrm>
                      <a:off x="5335920" y="440208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236" name=""/>
                  <p:cNvGrpSpPr/>
                  <p:nvPr/>
                </p:nvGrpSpPr>
                <p:grpSpPr>
                  <a:xfrm>
                    <a:off x="5190120" y="4402080"/>
                    <a:ext cx="64440" cy="27000"/>
                    <a:chOff x="5190120" y="4402080"/>
                    <a:chExt cx="64440" cy="27000"/>
                  </a:xfrm>
                </p:grpSpPr>
                <p:sp>
                  <p:nvSpPr>
                    <p:cNvPr id="237" name=""/>
                    <p:cNvSpPr/>
                    <p:nvPr/>
                  </p:nvSpPr>
                  <p:spPr>
                    <a:xfrm>
                      <a:off x="5190120" y="440208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38" name=""/>
                    <p:cNvSpPr/>
                    <p:nvPr/>
                  </p:nvSpPr>
                  <p:spPr>
                    <a:xfrm flipH="1">
                      <a:off x="5190120" y="440208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239" name=""/>
              <p:cNvGrpSpPr/>
              <p:nvPr/>
            </p:nvGrpSpPr>
            <p:grpSpPr>
              <a:xfrm>
                <a:off x="5441760" y="3973680"/>
                <a:ext cx="355680" cy="337320"/>
                <a:chOff x="5441760" y="3973680"/>
                <a:chExt cx="355680" cy="337320"/>
              </a:xfrm>
            </p:grpSpPr>
            <p:sp>
              <p:nvSpPr>
                <p:cNvPr id="240" name=""/>
                <p:cNvSpPr/>
                <p:nvPr/>
              </p:nvSpPr>
              <p:spPr>
                <a:xfrm>
                  <a:off x="5441760" y="3973680"/>
                  <a:ext cx="3556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41" name=""/>
                <p:cNvGrpSpPr/>
                <p:nvPr/>
              </p:nvGrpSpPr>
              <p:grpSpPr>
                <a:xfrm>
                  <a:off x="5507640" y="4117680"/>
                  <a:ext cx="210240" cy="26640"/>
                  <a:chOff x="5507640" y="4117680"/>
                  <a:chExt cx="210240" cy="26640"/>
                </a:xfrm>
              </p:grpSpPr>
              <p:grpSp>
                <p:nvGrpSpPr>
                  <p:cNvPr id="242" name=""/>
                  <p:cNvGrpSpPr/>
                  <p:nvPr/>
                </p:nvGrpSpPr>
                <p:grpSpPr>
                  <a:xfrm>
                    <a:off x="5653440" y="4117680"/>
                    <a:ext cx="64440" cy="26640"/>
                    <a:chOff x="5653440" y="4117680"/>
                    <a:chExt cx="64440" cy="26640"/>
                  </a:xfrm>
                </p:grpSpPr>
                <p:sp>
                  <p:nvSpPr>
                    <p:cNvPr id="243" name=""/>
                    <p:cNvSpPr/>
                    <p:nvPr/>
                  </p:nvSpPr>
                  <p:spPr>
                    <a:xfrm>
                      <a:off x="5717880" y="4117680"/>
                      <a:ext cx="0" cy="266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0160" bIns="-201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4" name=""/>
                    <p:cNvSpPr/>
                    <p:nvPr/>
                  </p:nvSpPr>
                  <p:spPr>
                    <a:xfrm>
                      <a:off x="5653440" y="411768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245" name=""/>
                  <p:cNvGrpSpPr/>
                  <p:nvPr/>
                </p:nvGrpSpPr>
                <p:grpSpPr>
                  <a:xfrm>
                    <a:off x="5507640" y="4117680"/>
                    <a:ext cx="64440" cy="26640"/>
                    <a:chOff x="5507640" y="4117680"/>
                    <a:chExt cx="64440" cy="26640"/>
                  </a:xfrm>
                </p:grpSpPr>
                <p:sp>
                  <p:nvSpPr>
                    <p:cNvPr id="246" name=""/>
                    <p:cNvSpPr/>
                    <p:nvPr/>
                  </p:nvSpPr>
                  <p:spPr>
                    <a:xfrm>
                      <a:off x="5507640" y="4117680"/>
                      <a:ext cx="0" cy="266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20160" bIns="-2016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47" name=""/>
                    <p:cNvSpPr/>
                    <p:nvPr/>
                  </p:nvSpPr>
                  <p:spPr>
                    <a:xfrm flipH="1">
                      <a:off x="5507640" y="411768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248" name=""/>
              <p:cNvGrpSpPr/>
              <p:nvPr/>
            </p:nvGrpSpPr>
            <p:grpSpPr>
              <a:xfrm>
                <a:off x="5752800" y="4462560"/>
                <a:ext cx="355680" cy="337320"/>
                <a:chOff x="5752800" y="4462560"/>
                <a:chExt cx="355680" cy="337320"/>
              </a:xfrm>
            </p:grpSpPr>
            <p:sp>
              <p:nvSpPr>
                <p:cNvPr id="249" name=""/>
                <p:cNvSpPr/>
                <p:nvPr/>
              </p:nvSpPr>
              <p:spPr>
                <a:xfrm>
                  <a:off x="5752800" y="4462560"/>
                  <a:ext cx="35568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50" name=""/>
                <p:cNvGrpSpPr/>
                <p:nvPr/>
              </p:nvGrpSpPr>
              <p:grpSpPr>
                <a:xfrm>
                  <a:off x="5818680" y="4606920"/>
                  <a:ext cx="210240" cy="27000"/>
                  <a:chOff x="5818680" y="4606920"/>
                  <a:chExt cx="210240" cy="27000"/>
                </a:xfrm>
              </p:grpSpPr>
              <p:grpSp>
                <p:nvGrpSpPr>
                  <p:cNvPr id="251" name=""/>
                  <p:cNvGrpSpPr/>
                  <p:nvPr/>
                </p:nvGrpSpPr>
                <p:grpSpPr>
                  <a:xfrm>
                    <a:off x="5964480" y="4606920"/>
                    <a:ext cx="64440" cy="27000"/>
                    <a:chOff x="5964480" y="4606920"/>
                    <a:chExt cx="64440" cy="27000"/>
                  </a:xfrm>
                </p:grpSpPr>
                <p:sp>
                  <p:nvSpPr>
                    <p:cNvPr id="252" name=""/>
                    <p:cNvSpPr/>
                    <p:nvPr/>
                  </p:nvSpPr>
                  <p:spPr>
                    <a:xfrm>
                      <a:off x="6028920" y="460692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3" name=""/>
                    <p:cNvSpPr/>
                    <p:nvPr/>
                  </p:nvSpPr>
                  <p:spPr>
                    <a:xfrm>
                      <a:off x="5964480" y="460692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254" name=""/>
                  <p:cNvGrpSpPr/>
                  <p:nvPr/>
                </p:nvGrpSpPr>
                <p:grpSpPr>
                  <a:xfrm>
                    <a:off x="5818680" y="4606920"/>
                    <a:ext cx="64440" cy="27000"/>
                    <a:chOff x="5818680" y="4606920"/>
                    <a:chExt cx="64440" cy="27000"/>
                  </a:xfrm>
                </p:grpSpPr>
                <p:sp>
                  <p:nvSpPr>
                    <p:cNvPr id="255" name=""/>
                    <p:cNvSpPr/>
                    <p:nvPr/>
                  </p:nvSpPr>
                  <p:spPr>
                    <a:xfrm>
                      <a:off x="5818680" y="460692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56" name=""/>
                    <p:cNvSpPr/>
                    <p:nvPr/>
                  </p:nvSpPr>
                  <p:spPr>
                    <a:xfrm flipH="1">
                      <a:off x="5818680" y="460692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grpSp>
            <p:nvGrpSpPr>
              <p:cNvPr id="257" name=""/>
              <p:cNvGrpSpPr/>
              <p:nvPr/>
            </p:nvGrpSpPr>
            <p:grpSpPr>
              <a:xfrm>
                <a:off x="6095880" y="4370400"/>
                <a:ext cx="355320" cy="337320"/>
                <a:chOff x="6095880" y="4370400"/>
                <a:chExt cx="355320" cy="337320"/>
              </a:xfrm>
            </p:grpSpPr>
            <p:sp>
              <p:nvSpPr>
                <p:cNvPr id="258" name=""/>
                <p:cNvSpPr/>
                <p:nvPr/>
              </p:nvSpPr>
              <p:spPr>
                <a:xfrm>
                  <a:off x="6095880" y="4370400"/>
                  <a:ext cx="355320" cy="337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100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*</a:t>
                  </a:r>
                  <a:endParaRPr b="0" lang="en-US" sz="1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59" name=""/>
                <p:cNvGrpSpPr/>
                <p:nvPr/>
              </p:nvGrpSpPr>
              <p:grpSpPr>
                <a:xfrm>
                  <a:off x="6161760" y="4514760"/>
                  <a:ext cx="210240" cy="27000"/>
                  <a:chOff x="6161760" y="4514760"/>
                  <a:chExt cx="210240" cy="27000"/>
                </a:xfrm>
              </p:grpSpPr>
              <p:grpSp>
                <p:nvGrpSpPr>
                  <p:cNvPr id="260" name=""/>
                  <p:cNvGrpSpPr/>
                  <p:nvPr/>
                </p:nvGrpSpPr>
                <p:grpSpPr>
                  <a:xfrm>
                    <a:off x="6307560" y="4514760"/>
                    <a:ext cx="64440" cy="27000"/>
                    <a:chOff x="6307560" y="4514760"/>
                    <a:chExt cx="64440" cy="27000"/>
                  </a:xfrm>
                </p:grpSpPr>
                <p:sp>
                  <p:nvSpPr>
                    <p:cNvPr id="261" name=""/>
                    <p:cNvSpPr/>
                    <p:nvPr/>
                  </p:nvSpPr>
                  <p:spPr>
                    <a:xfrm>
                      <a:off x="6372000" y="451476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2" name=""/>
                    <p:cNvSpPr/>
                    <p:nvPr/>
                  </p:nvSpPr>
                  <p:spPr>
                    <a:xfrm>
                      <a:off x="6307560" y="451476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263" name=""/>
                  <p:cNvGrpSpPr/>
                  <p:nvPr/>
                </p:nvGrpSpPr>
                <p:grpSpPr>
                  <a:xfrm>
                    <a:off x="6161760" y="4514760"/>
                    <a:ext cx="64440" cy="27000"/>
                    <a:chOff x="6161760" y="4514760"/>
                    <a:chExt cx="64440" cy="27000"/>
                  </a:xfrm>
                </p:grpSpPr>
                <p:sp>
                  <p:nvSpPr>
                    <p:cNvPr id="264" name=""/>
                    <p:cNvSpPr/>
                    <p:nvPr/>
                  </p:nvSpPr>
                  <p:spPr>
                    <a:xfrm>
                      <a:off x="6161760" y="4514760"/>
                      <a:ext cx="0" cy="270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19800" bIns="-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65" name=""/>
                    <p:cNvSpPr/>
                    <p:nvPr/>
                  </p:nvSpPr>
                  <p:spPr>
                    <a:xfrm flipH="1">
                      <a:off x="6161760" y="4514760"/>
                      <a:ext cx="6444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</p:grpSp>
        <p:sp>
          <p:nvSpPr>
            <p:cNvPr id="266" name=""/>
            <p:cNvSpPr/>
            <p:nvPr/>
          </p:nvSpPr>
          <p:spPr>
            <a:xfrm>
              <a:off x="326880" y="6019920"/>
              <a:ext cx="175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r>
                <a:rPr b="0" i="1" lang="it-IT" sz="12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r>
                <a:rPr b="0" lang="it-IT" sz="1200" spc="-1" strike="noStrike">
                  <a:solidFill>
                    <a:srgbClr val="000000"/>
                  </a:solidFill>
                  <a:latin typeface="Arial"/>
                </a:rPr>
                <a:t>&lt;0.0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67" name=""/>
            <p:cNvGrpSpPr/>
            <p:nvPr/>
          </p:nvGrpSpPr>
          <p:grpSpPr>
            <a:xfrm>
              <a:off x="6892920" y="304920"/>
              <a:ext cx="1240920" cy="448920"/>
              <a:chOff x="6892920" y="304920"/>
              <a:chExt cx="1240920" cy="448920"/>
            </a:xfrm>
          </p:grpSpPr>
          <p:sp>
            <p:nvSpPr>
              <p:cNvPr id="268" name=""/>
              <p:cNvSpPr/>
              <p:nvPr/>
            </p:nvSpPr>
            <p:spPr>
              <a:xfrm>
                <a:off x="6892920" y="328680"/>
                <a:ext cx="73080" cy="73080"/>
              </a:xfrm>
              <a:prstGeom prst="rect">
                <a:avLst/>
              </a:prstGeom>
              <a:solidFill>
                <a:srgbClr val="5f5f5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9" name=""/>
              <p:cNvSpPr/>
              <p:nvPr/>
            </p:nvSpPr>
            <p:spPr>
              <a:xfrm>
                <a:off x="6892920" y="492120"/>
                <a:ext cx="73080" cy="73080"/>
              </a:xfrm>
              <a:prstGeom prst="rect">
                <a:avLst/>
              </a:prstGeom>
              <a:solidFill>
                <a:srgbClr val="c0c0c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0" name=""/>
              <p:cNvSpPr/>
              <p:nvPr/>
            </p:nvSpPr>
            <p:spPr>
              <a:xfrm>
                <a:off x="6892920" y="657360"/>
                <a:ext cx="73080" cy="7272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5920" bIns="259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1" name="Rectangle 190"/>
              <p:cNvSpPr/>
              <p:nvPr/>
            </p:nvSpPr>
            <p:spPr>
              <a:xfrm>
                <a:off x="7022160" y="304920"/>
                <a:ext cx="11116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oup C (3MU LE-IFN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2" name="Rectangle 193"/>
              <p:cNvSpPr/>
              <p:nvPr/>
            </p:nvSpPr>
            <p:spPr>
              <a:xfrm>
                <a:off x="7022160" y="466560"/>
                <a:ext cx="1107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oup B (1MU LE-IFN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Symbol"/>
                    <a:ea typeface="Symbol"/>
                  </a:rPr>
                  <a:t>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3" name="Rectangle 196"/>
              <p:cNvSpPr/>
              <p:nvPr/>
            </p:nvSpPr>
            <p:spPr>
              <a:xfrm>
                <a:off x="7023240" y="631800"/>
                <a:ext cx="84528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oup A </a:t>
                </a:r>
                <a:r>
                  <a:rPr b="0" i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Placebo</a:t>
                </a:r>
                <a:r>
                  <a:rPr b="0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12T17:25:41Z</dcterms:created>
  <dc:creator>eleonora aricò</dc:creator>
  <dc:description/>
  <dc:language>en-US</dc:language>
  <cp:lastModifiedBy>eleonora aricò</cp:lastModifiedBy>
  <dcterms:modified xsi:type="dcterms:W3CDTF">2011-04-18T14:59:02Z</dcterms:modified>
  <cp:revision>4</cp:revision>
  <dc:subject/>
  <dc:title>Slide 1</dc:title>
</cp:coreProperties>
</file>